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thumbnail" Target="docProps/thumbnail.jpeg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6" Type="http://schemas.openxmlformats.org/officeDocument/2006/relationships/custom-properties" Target="docProps/custom.xml"/><Relationship Id="rId5" Type="http://schemas.openxmlformats.org/officeDocument/2006/relationships/extended-properties" Target="docProps/app.xml"/><Relationship Id="rId4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4"/>
  </p:sldMasterIdLst>
  <p:notesMasterIdLst>
    <p:notesMasterId r:id="rId6"/>
  </p:notesMasterIdLst>
  <p:sldIdLst>
    <p:sldId id="272" r:id="rId5"/>
  </p:sldIdLst>
  <p:sldSz cx="6264275" cy="6858000"/>
  <p:notesSz cx="6858000" cy="93138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3E1E1"/>
    <a:srgbClr val="34E635"/>
    <a:srgbClr val="ACE838"/>
    <a:srgbClr val="34FF34"/>
    <a:srgbClr val="B9B9B9"/>
    <a:srgbClr val="939318"/>
    <a:srgbClr val="E885E8"/>
    <a:srgbClr val="E32928"/>
    <a:srgbClr val="00C500"/>
    <a:srgbClr val="E8862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49" autoAdjust="0"/>
    <p:restoredTop sz="96279" autoAdjust="0"/>
  </p:normalViewPr>
  <p:slideViewPr>
    <p:cSldViewPr snapToGrid="0">
      <p:cViewPr varScale="1">
        <p:scale>
          <a:sx n="87" d="100"/>
          <a:sy n="87" d="100"/>
        </p:scale>
        <p:origin x="252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uBois, Jennifer" userId="fc8f9eb0-3f8f-46ae-af8b-fd777331bb29" providerId="ADAL" clId="{7E48C07A-5329-46E8-857A-9058F23B0894}"/>
    <pc:docChg chg="undo custSel modSld">
      <pc:chgData name="DuBois, Jennifer" userId="fc8f9eb0-3f8f-46ae-af8b-fd777331bb29" providerId="ADAL" clId="{7E48C07A-5329-46E8-857A-9058F23B0894}" dt="2024-11-27T02:34:35.310" v="1810" actId="1036"/>
      <pc:docMkLst>
        <pc:docMk/>
      </pc:docMkLst>
      <pc:sldChg chg="addSp delSp modSp mod">
        <pc:chgData name="DuBois, Jennifer" userId="fc8f9eb0-3f8f-46ae-af8b-fd777331bb29" providerId="ADAL" clId="{7E48C07A-5329-46E8-857A-9058F23B0894}" dt="2024-11-27T02:34:35.310" v="1810" actId="1036"/>
        <pc:sldMkLst>
          <pc:docMk/>
          <pc:sldMk cId="1900469891" sldId="272"/>
        </pc:sldMkLst>
      </pc:sldChg>
    </pc:docChg>
  </pc:docChgLst>
  <pc:docChgLst>
    <pc:chgData name="Lawrence, C Martin" userId="a1c56794-96be-4b4e-97be-4659eef358cd" providerId="ADAL" clId="{7572D6A0-4C24-4E1D-BDE9-2165D662C019}"/>
    <pc:docChg chg="modSld">
      <pc:chgData name="Lawrence, C Martin" userId="a1c56794-96be-4b4e-97be-4659eef358cd" providerId="ADAL" clId="{7572D6A0-4C24-4E1D-BDE9-2165D662C019}" dt="2025-07-09T14:26:51.917" v="58" actId="1076"/>
      <pc:docMkLst>
        <pc:docMk/>
      </pc:docMkLst>
      <pc:sldChg chg="addSp modSp mod">
        <pc:chgData name="Lawrence, C Martin" userId="a1c56794-96be-4b4e-97be-4659eef358cd" providerId="ADAL" clId="{7572D6A0-4C24-4E1D-BDE9-2165D662C019}" dt="2025-07-09T14:26:51.917" v="58" actId="1076"/>
        <pc:sldMkLst>
          <pc:docMk/>
          <pc:sldMk cId="1900469891" sldId="272"/>
        </pc:sldMkLst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2" creationId="{F39D5137-B812-B081-3BFE-55CC1BF51122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4" creationId="{9BA2A8BE-BE95-1E5D-7B6F-BA8171958329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13" creationId="{8A141FBE-1CCD-F325-AB71-8AF1B43E6547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14" creationId="{00084741-F67C-DBFE-610A-E832F408044D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21" creationId="{EA234F77-24DA-95E0-6A0F-9FCBB539FE1F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36" creationId="{910B38F9-81B7-37D9-85B5-9281ECEA0913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37" creationId="{3F235E17-6003-2D5C-C70F-43E4C0095F71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38" creationId="{66877B5E-BEF5-CC66-936E-62D37ABEF0BF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68" creationId="{81FC374D-9855-2A7A-A410-ACE7FB37EC68}"/>
          </ac:spMkLst>
        </pc:spChg>
        <pc:spChg chg="mod">
          <ac:chgData name="Lawrence, C Martin" userId="a1c56794-96be-4b4e-97be-4659eef358cd" providerId="ADAL" clId="{7572D6A0-4C24-4E1D-BDE9-2165D662C019}" dt="2025-07-09T14:25:14.723" v="0" actId="164"/>
          <ac:spMkLst>
            <pc:docMk/>
            <pc:sldMk cId="1900469891" sldId="272"/>
            <ac:spMk id="79" creationId="{6E8D0EF2-43A6-3EDC-3F65-AF7D316039D4}"/>
          </ac:spMkLst>
        </pc:spChg>
        <pc:grpChg chg="mod">
          <ac:chgData name="Lawrence, C Martin" userId="a1c56794-96be-4b4e-97be-4659eef358cd" providerId="ADAL" clId="{7572D6A0-4C24-4E1D-BDE9-2165D662C019}" dt="2025-07-09T14:26:51.917" v="58" actId="1076"/>
          <ac:grpSpMkLst>
            <pc:docMk/>
            <pc:sldMk cId="1900469891" sldId="272"/>
            <ac:grpSpMk id="3" creationId="{5E36F78E-9E4D-3656-98AB-F59C43C4B7F5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398B518-4272-4621-B73D-CD3FD3B7020D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993900" y="1163638"/>
            <a:ext cx="2870200" cy="31432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81514"/>
            <a:ext cx="5486400" cy="36687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47139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847139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8F3161-4536-43BA-B8B9-C3D0B1FD71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359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993900" y="1163638"/>
            <a:ext cx="2870200" cy="31432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8F3161-4536-43BA-B8B9-C3D0B1FD71E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62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122363"/>
            <a:ext cx="5324634" cy="2387600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3602038"/>
            <a:ext cx="4698206" cy="1655762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1687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7695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365125"/>
            <a:ext cx="1350734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365125"/>
            <a:ext cx="397389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780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568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1709740"/>
            <a:ext cx="5402937" cy="2852737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4589465"/>
            <a:ext cx="5402937" cy="1500187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582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1825625"/>
            <a:ext cx="2662317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1825625"/>
            <a:ext cx="2662317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1007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365127"/>
            <a:ext cx="5402937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1681163"/>
            <a:ext cx="2650082" cy="82391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2505075"/>
            <a:ext cx="265008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1681163"/>
            <a:ext cx="2663133" cy="82391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2505075"/>
            <a:ext cx="2663133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7875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72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448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57200"/>
            <a:ext cx="2020392" cy="160020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987427"/>
            <a:ext cx="3171289" cy="487362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057400"/>
            <a:ext cx="2020392" cy="381158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920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57200"/>
            <a:ext cx="2020392" cy="1600200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987427"/>
            <a:ext cx="3171289" cy="487362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057400"/>
            <a:ext cx="2020392" cy="381158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3422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365127"/>
            <a:ext cx="5402937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1825625"/>
            <a:ext cx="5402937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6356352"/>
            <a:ext cx="14094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93524A-635E-4CC4-BA4C-753BC5EAA9DE}" type="datetimeFigureOut">
              <a:rPr lang="en-US" smtClean="0"/>
              <a:t>7/9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6356352"/>
            <a:ext cx="211419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6356352"/>
            <a:ext cx="140946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A97F1E-0839-4902-AFBC-78593FD9C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0250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E36F78E-9E4D-3656-98AB-F59C43C4B7F5}"/>
              </a:ext>
            </a:extLst>
          </p:cNvPr>
          <p:cNvGrpSpPr/>
          <p:nvPr/>
        </p:nvGrpSpPr>
        <p:grpSpPr>
          <a:xfrm>
            <a:off x="0" y="0"/>
            <a:ext cx="6331212" cy="6815452"/>
            <a:chOff x="-66937" y="241122"/>
            <a:chExt cx="6331212" cy="6815452"/>
          </a:xfrm>
        </p:grpSpPr>
        <p:pic>
          <p:nvPicPr>
            <p:cNvPr id="5" name="Picture 4" descr="A colorful cluster of dna&#10;&#10;Description automatically generated with medium confidence">
              <a:extLst>
                <a:ext uri="{FF2B5EF4-FFF2-40B4-BE49-F238E27FC236}">
                  <a16:creationId xmlns:a16="http://schemas.microsoft.com/office/drawing/2014/main" id="{0D188BEE-0B34-D7C3-5541-EDFEDFD4D34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9332" b="7257"/>
            <a:stretch/>
          </p:blipFill>
          <p:spPr>
            <a:xfrm>
              <a:off x="-66937" y="312162"/>
              <a:ext cx="2828368" cy="2103915"/>
            </a:xfrm>
            <a:prstGeom prst="rect">
              <a:avLst/>
            </a:prstGeom>
          </p:spPr>
        </p:pic>
        <p:pic>
          <p:nvPicPr>
            <p:cNvPr id="7" name="Picture 6" descr="A colorful cluster of dna&#10;&#10;Description automatically generated with medium confidence">
              <a:extLst>
                <a:ext uri="{FF2B5EF4-FFF2-40B4-BE49-F238E27FC236}">
                  <a16:creationId xmlns:a16="http://schemas.microsoft.com/office/drawing/2014/main" id="{1ACA0ABF-FBEF-6C5E-BC30-44DF1C683B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963" r="9705" b="18323"/>
            <a:stretch/>
          </p:blipFill>
          <p:spPr>
            <a:xfrm>
              <a:off x="3085127" y="274915"/>
              <a:ext cx="2755497" cy="1852878"/>
            </a:xfrm>
            <a:prstGeom prst="rect">
              <a:avLst/>
            </a:prstGeom>
          </p:spPr>
        </p:pic>
        <p:pic>
          <p:nvPicPr>
            <p:cNvPr id="9" name="Picture 8" descr="A colorful structure with blue and yellow dots&#10;&#10;Description automatically generated with medium confidence">
              <a:extLst>
                <a:ext uri="{FF2B5EF4-FFF2-40B4-BE49-F238E27FC236}">
                  <a16:creationId xmlns:a16="http://schemas.microsoft.com/office/drawing/2014/main" id="{DB0123CB-08FC-412C-03EE-62993CCBB4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832" r="9332" b="19361"/>
            <a:stretch/>
          </p:blipFill>
          <p:spPr>
            <a:xfrm>
              <a:off x="1" y="2421696"/>
              <a:ext cx="2771220" cy="1829331"/>
            </a:xfrm>
            <a:prstGeom prst="rect">
              <a:avLst/>
            </a:prstGeom>
          </p:spPr>
        </p:pic>
        <p:pic>
          <p:nvPicPr>
            <p:cNvPr id="11" name="Picture 10" descr="A computer screen shot of a colorful structure&#10;&#10;Description automatically generated">
              <a:extLst>
                <a:ext uri="{FF2B5EF4-FFF2-40B4-BE49-F238E27FC236}">
                  <a16:creationId xmlns:a16="http://schemas.microsoft.com/office/drawing/2014/main" id="{DFD531E3-1AFE-50E1-F172-BC30D44053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7671" r="4248" b="17639"/>
            <a:stretch/>
          </p:blipFill>
          <p:spPr>
            <a:xfrm>
              <a:off x="3132138" y="2382632"/>
              <a:ext cx="2747668" cy="1868395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B076F910-EFB0-D9DE-8962-C5931AF0447C}"/>
                </a:ext>
              </a:extLst>
            </p:cNvPr>
            <p:cNvSpPr/>
            <p:nvPr/>
          </p:nvSpPr>
          <p:spPr>
            <a:xfrm>
              <a:off x="110628" y="332436"/>
              <a:ext cx="22920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8A141FBE-1CCD-F325-AB71-8AF1B43E6547}"/>
                </a:ext>
              </a:extLst>
            </p:cNvPr>
            <p:cNvSpPr/>
            <p:nvPr/>
          </p:nvSpPr>
          <p:spPr>
            <a:xfrm>
              <a:off x="3163769" y="332436"/>
              <a:ext cx="23618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00084741-F67C-DBFE-610A-E832F408044D}"/>
                </a:ext>
              </a:extLst>
            </p:cNvPr>
            <p:cNvSpPr/>
            <p:nvPr/>
          </p:nvSpPr>
          <p:spPr>
            <a:xfrm>
              <a:off x="127589" y="2421242"/>
              <a:ext cx="22920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49499776-8148-0E61-EE99-48790F910256}"/>
                </a:ext>
              </a:extLst>
            </p:cNvPr>
            <p:cNvSpPr/>
            <p:nvPr/>
          </p:nvSpPr>
          <p:spPr>
            <a:xfrm>
              <a:off x="3190348" y="2421242"/>
              <a:ext cx="236185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BA2A8BE-BE95-1E5D-7B6F-BA8171958329}"/>
                </a:ext>
              </a:extLst>
            </p:cNvPr>
            <p:cNvSpPr txBox="1"/>
            <p:nvPr/>
          </p:nvSpPr>
          <p:spPr>
            <a:xfrm>
              <a:off x="-10802" y="862208"/>
              <a:ext cx="87171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3E3E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a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F1A5044-ACBF-2F23-2359-884864CE2779}"/>
                </a:ext>
              </a:extLst>
            </p:cNvPr>
            <p:cNvSpPr txBox="1"/>
            <p:nvPr/>
          </p:nvSpPr>
          <p:spPr>
            <a:xfrm>
              <a:off x="2145254" y="2041970"/>
              <a:ext cx="778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E885E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 VI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F966C8B-94A5-3FAE-9C6D-30055F7F514C}"/>
                </a:ext>
              </a:extLst>
            </p:cNvPr>
            <p:cNvSpPr txBox="1"/>
            <p:nvPr/>
          </p:nvSpPr>
          <p:spPr>
            <a:xfrm>
              <a:off x="3921852" y="2007643"/>
              <a:ext cx="69951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E3292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 V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76FDF0D-FD76-98A2-7D1C-659F12658D1C}"/>
                </a:ext>
              </a:extLst>
            </p:cNvPr>
            <p:cNvSpPr txBox="1"/>
            <p:nvPr/>
          </p:nvSpPr>
          <p:spPr>
            <a:xfrm>
              <a:off x="486591" y="703256"/>
              <a:ext cx="5183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23E1E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ck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7D63243-5B34-0942-4247-A4156A76CC88}"/>
                </a:ext>
              </a:extLst>
            </p:cNvPr>
            <p:cNvSpPr txBox="1"/>
            <p:nvPr/>
          </p:nvSpPr>
          <p:spPr>
            <a:xfrm>
              <a:off x="1563573" y="241122"/>
              <a:ext cx="89155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E88625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 IV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DD07554-F9D0-B6F5-1B66-766E79835795}"/>
                </a:ext>
              </a:extLst>
            </p:cNvPr>
            <p:cNvSpPr txBox="1"/>
            <p:nvPr/>
          </p:nvSpPr>
          <p:spPr>
            <a:xfrm>
              <a:off x="4383783" y="2033966"/>
              <a:ext cx="77802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30923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op I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CD803188-1D4E-ADFA-6708-3CF5C892D215}"/>
                </a:ext>
              </a:extLst>
            </p:cNvPr>
            <p:cNvSpPr txBox="1"/>
            <p:nvPr/>
          </p:nvSpPr>
          <p:spPr>
            <a:xfrm>
              <a:off x="637707" y="2189530"/>
              <a:ext cx="8841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00C5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 III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6ADE5BC-0481-7B21-8D9A-BDD6608D9A40}"/>
                </a:ext>
              </a:extLst>
            </p:cNvPr>
            <p:cNvSpPr txBox="1"/>
            <p:nvPr/>
          </p:nvSpPr>
          <p:spPr>
            <a:xfrm>
              <a:off x="3879322" y="4080938"/>
              <a:ext cx="6512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E32928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m V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EA234F77-24DA-95E0-6A0F-9FCBB539FE1F}"/>
                </a:ext>
              </a:extLst>
            </p:cNvPr>
            <p:cNvSpPr txBox="1"/>
            <p:nvPr/>
          </p:nvSpPr>
          <p:spPr>
            <a:xfrm>
              <a:off x="3212893" y="3010796"/>
              <a:ext cx="53773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3E3ECC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ead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71A09B6-4DF0-5D8E-B4F6-F09C72B5AD74}"/>
                </a:ext>
              </a:extLst>
            </p:cNvPr>
            <p:cNvSpPr txBox="1"/>
            <p:nvPr/>
          </p:nvSpPr>
          <p:spPr>
            <a:xfrm>
              <a:off x="5106051" y="2117621"/>
              <a:ext cx="11582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highlight>
                    <a:srgbClr val="ACE838"/>
                  </a:highlight>
                  <a:latin typeface="Arial" panose="020B0604020202020204" pitchFamily="34" charset="0"/>
                  <a:cs typeface="Arial" panose="020B0604020202020204" pitchFamily="34" charset="0"/>
                </a:rPr>
                <a:t>Na1, Na2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8FCD4697-6C44-DA6B-4CA7-023FC0D3A2C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815452" y="1559262"/>
              <a:ext cx="391392" cy="568531"/>
            </a:xfrm>
            <a:prstGeom prst="straightConnector1">
              <a:avLst/>
            </a:prstGeom>
            <a:ln w="190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713E5DEB-F3CB-C163-F796-71BB034FA4B7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009516" y="1637414"/>
              <a:ext cx="556644" cy="480207"/>
            </a:xfrm>
            <a:prstGeom prst="straightConnector1">
              <a:avLst/>
            </a:prstGeom>
            <a:ln w="190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0F45E77-9CA7-7454-7A01-53F6A6338B05}"/>
                </a:ext>
              </a:extLst>
            </p:cNvPr>
            <p:cNvSpPr txBox="1"/>
            <p:nvPr/>
          </p:nvSpPr>
          <p:spPr>
            <a:xfrm>
              <a:off x="5035679" y="3587293"/>
              <a:ext cx="65127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a2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10B38F9-81B7-37D9-85B5-9281ECEA0913}"/>
                </a:ext>
              </a:extLst>
            </p:cNvPr>
            <p:cNvSpPr txBox="1"/>
            <p:nvPr/>
          </p:nvSpPr>
          <p:spPr>
            <a:xfrm>
              <a:off x="1897304" y="3594652"/>
              <a:ext cx="53135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Na2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F235E17-6003-2D5C-C70F-43E4C0095F71}"/>
                </a:ext>
              </a:extLst>
            </p:cNvPr>
            <p:cNvSpPr txBox="1"/>
            <p:nvPr/>
          </p:nvSpPr>
          <p:spPr>
            <a:xfrm>
              <a:off x="3624771" y="2860209"/>
              <a:ext cx="79494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Heme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6877B5E-BEF5-CC66-936E-62D37ABEF0BF}"/>
                </a:ext>
              </a:extLst>
            </p:cNvPr>
            <p:cNvSpPr txBox="1"/>
            <p:nvPr/>
          </p:nvSpPr>
          <p:spPr>
            <a:xfrm>
              <a:off x="912151" y="4179479"/>
              <a:ext cx="75567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PIX</a:t>
              </a:r>
            </a:p>
          </p:txBody>
        </p: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287F8078-C7C8-4C28-A86F-C8B8002CDAC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225523" y="3785204"/>
              <a:ext cx="390626" cy="432927"/>
            </a:xfrm>
            <a:prstGeom prst="straightConnector1">
              <a:avLst/>
            </a:prstGeom>
            <a:ln w="190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D5CCE087-601B-D490-8CD1-362D80A6D31D}"/>
                </a:ext>
              </a:extLst>
            </p:cNvPr>
            <p:cNvCxnSpPr>
              <a:cxnSpLocks/>
            </p:cNvCxnSpPr>
            <p:nvPr/>
          </p:nvCxnSpPr>
          <p:spPr>
            <a:xfrm>
              <a:off x="3921852" y="3103419"/>
              <a:ext cx="53812" cy="275133"/>
            </a:xfrm>
            <a:prstGeom prst="straightConnector1">
              <a:avLst/>
            </a:prstGeom>
            <a:ln w="19050">
              <a:solidFill>
                <a:schemeClr val="bg2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" name="Rectangle 1">
              <a:extLst>
                <a:ext uri="{FF2B5EF4-FFF2-40B4-BE49-F238E27FC236}">
                  <a16:creationId xmlns:a16="http://schemas.microsoft.com/office/drawing/2014/main" id="{F39D5137-B812-B081-3BFE-55CC1BF51122}"/>
                </a:ext>
              </a:extLst>
            </p:cNvPr>
            <p:cNvSpPr/>
            <p:nvPr/>
          </p:nvSpPr>
          <p:spPr>
            <a:xfrm>
              <a:off x="182991" y="4303007"/>
              <a:ext cx="229206" cy="2616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E6EA19CF-3131-A79B-A830-E41B4FD7ACA6}"/>
                </a:ext>
              </a:extLst>
            </p:cNvPr>
            <p:cNvSpPr/>
            <p:nvPr/>
          </p:nvSpPr>
          <p:spPr>
            <a:xfrm>
              <a:off x="3314237" y="4336274"/>
              <a:ext cx="23115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A2D9AB33-2388-EDBE-B654-DC530B0BC3C0}"/>
                </a:ext>
              </a:extLst>
            </p:cNvPr>
            <p:cNvGrpSpPr/>
            <p:nvPr/>
          </p:nvGrpSpPr>
          <p:grpSpPr>
            <a:xfrm>
              <a:off x="214652" y="4589742"/>
              <a:ext cx="2629228" cy="2466832"/>
              <a:chOff x="3244943" y="5238316"/>
              <a:chExt cx="2629228" cy="2466832"/>
            </a:xfrm>
          </p:grpSpPr>
          <p:grpSp>
            <p:nvGrpSpPr>
              <p:cNvPr id="50" name="Group 49">
                <a:extLst>
                  <a:ext uri="{FF2B5EF4-FFF2-40B4-BE49-F238E27FC236}">
                    <a16:creationId xmlns:a16="http://schemas.microsoft.com/office/drawing/2014/main" id="{63A5C4AF-3B8E-3290-D4D7-6C096608E421}"/>
                  </a:ext>
                </a:extLst>
              </p:cNvPr>
              <p:cNvGrpSpPr/>
              <p:nvPr/>
            </p:nvGrpSpPr>
            <p:grpSpPr>
              <a:xfrm>
                <a:off x="3244943" y="5238316"/>
                <a:ext cx="2629228" cy="2466832"/>
                <a:chOff x="9618" y="27145"/>
                <a:chExt cx="3019332" cy="2984200"/>
              </a:xfrm>
            </p:grpSpPr>
            <p:pic>
              <p:nvPicPr>
                <p:cNvPr id="55" name="Picture 54">
                  <a:extLst>
                    <a:ext uri="{FF2B5EF4-FFF2-40B4-BE49-F238E27FC236}">
                      <a16:creationId xmlns:a16="http://schemas.microsoft.com/office/drawing/2014/main" id="{C33DF55E-43A3-6CB3-CF14-1F5029BD95C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rcRect l="26231" t="902" r="26231"/>
                <a:stretch/>
              </p:blipFill>
              <p:spPr>
                <a:xfrm>
                  <a:off x="9618" y="27145"/>
                  <a:ext cx="3019332" cy="2984200"/>
                </a:xfrm>
                <a:prstGeom prst="rect">
                  <a:avLst/>
                </a:prstGeom>
              </p:spPr>
            </p:pic>
            <p:sp>
              <p:nvSpPr>
                <p:cNvPr id="56" name="TextBox 55">
                  <a:extLst>
                    <a:ext uri="{FF2B5EF4-FFF2-40B4-BE49-F238E27FC236}">
                      <a16:creationId xmlns:a16="http://schemas.microsoft.com/office/drawing/2014/main" id="{6EF61153-FCCF-34C5-764A-BC80FE8ECBEA}"/>
                    </a:ext>
                  </a:extLst>
                </p:cNvPr>
                <p:cNvSpPr txBox="1"/>
                <p:nvPr/>
              </p:nvSpPr>
              <p:spPr>
                <a:xfrm>
                  <a:off x="1683777" y="1505813"/>
                  <a:ext cx="600484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254</a:t>
                  </a:r>
                </a:p>
              </p:txBody>
            </p: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C78D2DAB-C728-D33E-ACFF-F49861380A90}"/>
                    </a:ext>
                  </a:extLst>
                </p:cNvPr>
                <p:cNvSpPr txBox="1"/>
                <p:nvPr/>
              </p:nvSpPr>
              <p:spPr>
                <a:xfrm>
                  <a:off x="926754" y="1663834"/>
                  <a:ext cx="526850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79</a:t>
                  </a:r>
                </a:p>
              </p:txBody>
            </p: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1A87722A-793E-6958-8B56-C0E0935A30CD}"/>
                    </a:ext>
                  </a:extLst>
                </p:cNvPr>
                <p:cNvSpPr txBox="1"/>
                <p:nvPr/>
              </p:nvSpPr>
              <p:spPr>
                <a:xfrm>
                  <a:off x="303556" y="2333965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3</a:t>
                  </a:r>
                </a:p>
              </p:txBody>
            </p: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7F69F25C-EE8D-0C71-0A70-FF96AC65E596}"/>
                    </a:ext>
                  </a:extLst>
                </p:cNvPr>
                <p:cNvSpPr txBox="1"/>
                <p:nvPr/>
              </p:nvSpPr>
              <p:spPr>
                <a:xfrm>
                  <a:off x="63931" y="2135619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4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456FF105-8345-C357-450B-F16497E56D61}"/>
                    </a:ext>
                  </a:extLst>
                </p:cNvPr>
                <p:cNvSpPr txBox="1"/>
                <p:nvPr/>
              </p:nvSpPr>
              <p:spPr>
                <a:xfrm>
                  <a:off x="169504" y="2682531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1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56FE61D2-3AB7-5B90-D732-136B90FB8A46}"/>
                    </a:ext>
                  </a:extLst>
                </p:cNvPr>
                <p:cNvSpPr txBox="1"/>
                <p:nvPr/>
              </p:nvSpPr>
              <p:spPr>
                <a:xfrm>
                  <a:off x="197821" y="1203283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100" b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</p:grp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44624EE2-CAAB-BF32-EF08-2F02607D7587}"/>
                  </a:ext>
                </a:extLst>
              </p:cNvPr>
              <p:cNvSpPr txBox="1"/>
              <p:nvPr/>
            </p:nvSpPr>
            <p:spPr>
              <a:xfrm>
                <a:off x="4679802" y="5409687"/>
                <a:ext cx="3497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7</a:t>
                </a: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A2A725B7-6423-F8EE-767B-F3D311B452EB}"/>
                  </a:ext>
                </a:extLst>
              </p:cNvPr>
              <p:cNvSpPr txBox="1"/>
              <p:nvPr/>
            </p:nvSpPr>
            <p:spPr>
              <a:xfrm>
                <a:off x="4208421" y="5288625"/>
                <a:ext cx="3497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β8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34EC84C9-BE4E-FD67-2F1D-57E09F3D6D74}"/>
                  </a:ext>
                </a:extLst>
              </p:cNvPr>
              <p:cNvSpPr txBox="1"/>
              <p:nvPr/>
            </p:nvSpPr>
            <p:spPr>
              <a:xfrm>
                <a:off x="5009516" y="5890496"/>
                <a:ext cx="3497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5</a:t>
                </a: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90D071FD-4BB0-DF2E-0114-049ED8120432}"/>
                  </a:ext>
                </a:extLst>
              </p:cNvPr>
              <p:cNvSpPr txBox="1"/>
              <p:nvPr/>
            </p:nvSpPr>
            <p:spPr>
              <a:xfrm>
                <a:off x="5206844" y="6551794"/>
                <a:ext cx="3497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α6</a:t>
                </a:r>
              </a:p>
            </p:txBody>
          </p:sp>
        </p:grpSp>
        <p:grpSp>
          <p:nvGrpSpPr>
            <p:cNvPr id="82" name="Group 81">
              <a:extLst>
                <a:ext uri="{FF2B5EF4-FFF2-40B4-BE49-F238E27FC236}">
                  <a16:creationId xmlns:a16="http://schemas.microsoft.com/office/drawing/2014/main" id="{9B1DEAC0-7CA8-33E4-0545-193BB99BA08D}"/>
                </a:ext>
              </a:extLst>
            </p:cNvPr>
            <p:cNvGrpSpPr/>
            <p:nvPr/>
          </p:nvGrpSpPr>
          <p:grpSpPr>
            <a:xfrm>
              <a:off x="3091039" y="4543657"/>
              <a:ext cx="2880528" cy="2429486"/>
              <a:chOff x="-77483" y="5325140"/>
              <a:chExt cx="2880528" cy="2429486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80C9E0FA-9E50-D1AE-A753-6FAF359C5ECB}"/>
                  </a:ext>
                </a:extLst>
              </p:cNvPr>
              <p:cNvGrpSpPr/>
              <p:nvPr/>
            </p:nvGrpSpPr>
            <p:grpSpPr>
              <a:xfrm>
                <a:off x="-77483" y="5325140"/>
                <a:ext cx="2880528" cy="2429486"/>
                <a:chOff x="3014448" y="100181"/>
                <a:chExt cx="3307919" cy="2939022"/>
              </a:xfrm>
            </p:grpSpPr>
            <p:pic>
              <p:nvPicPr>
                <p:cNvPr id="26" name="Picture 25">
                  <a:extLst>
                    <a:ext uri="{FF2B5EF4-FFF2-40B4-BE49-F238E27FC236}">
                      <a16:creationId xmlns:a16="http://schemas.microsoft.com/office/drawing/2014/main" id="{BDA34C22-EFFC-8974-44CE-3021D459EAC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40414" t="20201" r="30894" b="23795"/>
                <a:stretch/>
              </p:blipFill>
              <p:spPr>
                <a:xfrm>
                  <a:off x="3108917" y="100181"/>
                  <a:ext cx="3145740" cy="2911164"/>
                </a:xfrm>
                <a:prstGeom prst="rect">
                  <a:avLst/>
                </a:prstGeom>
              </p:spPr>
            </p:pic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BD2726ED-E003-663D-AB6E-B439895B2B4B}"/>
                    </a:ext>
                  </a:extLst>
                </p:cNvPr>
                <p:cNvSpPr txBox="1"/>
                <p:nvPr/>
              </p:nvSpPr>
              <p:spPr>
                <a:xfrm>
                  <a:off x="3184065" y="184666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β</a:t>
                  </a:r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7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308EFF65-17BF-E895-BD48-3F78DF2ADE76}"/>
                    </a:ext>
                  </a:extLst>
                </p:cNvPr>
                <p:cNvSpPr txBox="1"/>
                <p:nvPr/>
              </p:nvSpPr>
              <p:spPr>
                <a:xfrm>
                  <a:off x="3014448" y="1517145"/>
                  <a:ext cx="4918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74E96BFB-930C-A13D-5E91-CC145A002970}"/>
                    </a:ext>
                  </a:extLst>
                </p:cNvPr>
                <p:cNvSpPr txBox="1"/>
                <p:nvPr/>
              </p:nvSpPr>
              <p:spPr>
                <a:xfrm>
                  <a:off x="5857886" y="833952"/>
                  <a:ext cx="4016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</a:p>
              </p:txBody>
            </p:sp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CDDC5E8A-87F0-39C1-9772-AA466173A39B}"/>
                    </a:ext>
                  </a:extLst>
                </p:cNvPr>
                <p:cNvSpPr txBox="1"/>
                <p:nvPr/>
              </p:nvSpPr>
              <p:spPr>
                <a:xfrm>
                  <a:off x="4748950" y="2722726"/>
                  <a:ext cx="4918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4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D322F976-914E-04D8-8DF4-10CF73983A09}"/>
                    </a:ext>
                  </a:extLst>
                </p:cNvPr>
                <p:cNvSpPr txBox="1"/>
                <p:nvPr/>
              </p:nvSpPr>
              <p:spPr>
                <a:xfrm>
                  <a:off x="5258988" y="2663796"/>
                  <a:ext cx="491873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l-GR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450502AB-9C90-17B7-C2A5-6343B6661412}"/>
                    </a:ext>
                  </a:extLst>
                </p:cNvPr>
                <p:cNvSpPr txBox="1"/>
                <p:nvPr/>
              </p:nvSpPr>
              <p:spPr>
                <a:xfrm>
                  <a:off x="5640886" y="1684303"/>
                  <a:ext cx="681481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1146</a:t>
                  </a: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66C367D7-A3BA-3132-4AF0-7478700B6A5C}"/>
                    </a:ext>
                  </a:extLst>
                </p:cNvPr>
                <p:cNvSpPr txBox="1"/>
                <p:nvPr/>
              </p:nvSpPr>
              <p:spPr>
                <a:xfrm>
                  <a:off x="5034462" y="2033540"/>
                  <a:ext cx="698049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Q1142</a:t>
                  </a:r>
                </a:p>
              </p:txBody>
            </p:sp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87A632A8-CCD6-B908-1137-6F6F3FFC9697}"/>
                    </a:ext>
                  </a:extLst>
                </p:cNvPr>
                <p:cNvSpPr txBox="1"/>
                <p:nvPr/>
              </p:nvSpPr>
              <p:spPr>
                <a:xfrm>
                  <a:off x="5127426" y="757501"/>
                  <a:ext cx="681481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1281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A4498206-065D-5189-A99E-7CD92FADDA7D}"/>
                    </a:ext>
                  </a:extLst>
                </p:cNvPr>
                <p:cNvSpPr txBox="1"/>
                <p:nvPr/>
              </p:nvSpPr>
              <p:spPr>
                <a:xfrm>
                  <a:off x="5186164" y="2440477"/>
                  <a:ext cx="681481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1143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F403A6A6-569D-74A4-79DB-A1013FFDD65B}"/>
                    </a:ext>
                  </a:extLst>
                </p:cNvPr>
                <p:cNvSpPr txBox="1"/>
                <p:nvPr/>
              </p:nvSpPr>
              <p:spPr>
                <a:xfrm>
                  <a:off x="3790420" y="1048019"/>
                  <a:ext cx="600484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538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97E0872D-4BB4-BF2F-A98B-392B98006673}"/>
                    </a:ext>
                  </a:extLst>
                </p:cNvPr>
                <p:cNvSpPr txBox="1"/>
                <p:nvPr/>
              </p:nvSpPr>
              <p:spPr>
                <a:xfrm>
                  <a:off x="3843830" y="2032556"/>
                  <a:ext cx="690685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1209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E9919E4C-1E48-37CF-6E2D-B710ED6E5C9C}"/>
                    </a:ext>
                  </a:extLst>
                </p:cNvPr>
                <p:cNvSpPr txBox="1"/>
                <p:nvPr/>
              </p:nvSpPr>
              <p:spPr>
                <a:xfrm>
                  <a:off x="4584817" y="1363637"/>
                  <a:ext cx="690685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1208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C15EDBE7-AEC9-F83F-9D5B-29B4F442E043}"/>
                    </a:ext>
                  </a:extLst>
                </p:cNvPr>
                <p:cNvSpPr txBox="1"/>
                <p:nvPr/>
              </p:nvSpPr>
              <p:spPr>
                <a:xfrm>
                  <a:off x="4027153" y="2398841"/>
                  <a:ext cx="681481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1212</a:t>
                  </a:r>
                </a:p>
              </p:txBody>
            </p:sp>
            <p:sp>
              <p:nvSpPr>
                <p:cNvPr id="48" name="TextBox 47">
                  <a:extLst>
                    <a:ext uri="{FF2B5EF4-FFF2-40B4-BE49-F238E27FC236}">
                      <a16:creationId xmlns:a16="http://schemas.microsoft.com/office/drawing/2014/main" id="{8F40B5A2-379D-744C-6A9B-6F44B3609133}"/>
                    </a:ext>
                  </a:extLst>
                </p:cNvPr>
                <p:cNvSpPr txBox="1"/>
                <p:nvPr/>
              </p:nvSpPr>
              <p:spPr>
                <a:xfrm>
                  <a:off x="3402515" y="1781870"/>
                  <a:ext cx="591280" cy="3164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577</a:t>
                  </a:r>
                </a:p>
              </p:txBody>
            </p:sp>
          </p:grp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C6B0F07C-9AA0-0857-5399-4EA4449FCBA8}"/>
                  </a:ext>
                </a:extLst>
              </p:cNvPr>
              <p:cNvSpPr txBox="1"/>
              <p:nvPr/>
            </p:nvSpPr>
            <p:spPr>
              <a:xfrm>
                <a:off x="860916" y="6289589"/>
                <a:ext cx="57200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1</a:t>
                </a:r>
              </a:p>
            </p:txBody>
          </p: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D10CF199-D7BC-6573-5538-78EB8A3BCB19}"/>
                  </a:ext>
                </a:extLst>
              </p:cNvPr>
              <p:cNvSpPr txBox="1"/>
              <p:nvPr/>
            </p:nvSpPr>
            <p:spPr>
              <a:xfrm>
                <a:off x="1812813" y="6401111"/>
                <a:ext cx="47070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a2</a:t>
                </a:r>
              </a:p>
            </p:txBody>
          </p:sp>
        </p:grp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1FC374D-9855-2A7A-A410-ACE7FB37EC68}"/>
                </a:ext>
              </a:extLst>
            </p:cNvPr>
            <p:cNvSpPr txBox="1"/>
            <p:nvPr/>
          </p:nvSpPr>
          <p:spPr>
            <a:xfrm>
              <a:off x="2495301" y="933284"/>
              <a:ext cx="8841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  <a:r>
                <a:rPr lang="en-US" sz="1100" b="1" dirty="0">
                  <a:solidFill>
                    <a:srgbClr val="00C5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Dom III</a:t>
              </a:r>
            </a:p>
          </p:txBody>
        </p:sp>
        <p:pic>
          <p:nvPicPr>
            <p:cNvPr id="70" name="Graphic 69" descr="Arrow Right with solid fill">
              <a:extLst>
                <a:ext uri="{FF2B5EF4-FFF2-40B4-BE49-F238E27FC236}">
                  <a16:creationId xmlns:a16="http://schemas.microsoft.com/office/drawing/2014/main" id="{5C445971-1783-D389-4309-2F0A3DFA4CC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2661477" y="1015112"/>
              <a:ext cx="502496" cy="425857"/>
            </a:xfrm>
            <a:prstGeom prst="rect">
              <a:avLst/>
            </a:prstGeom>
          </p:spPr>
        </p:pic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6E8D0EF2-43A6-3EDC-3F65-AF7D316039D4}"/>
                </a:ext>
              </a:extLst>
            </p:cNvPr>
            <p:cNvSpPr txBox="1"/>
            <p:nvPr/>
          </p:nvSpPr>
          <p:spPr>
            <a:xfrm>
              <a:off x="2610487" y="3190944"/>
              <a:ext cx="88416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-)</a:t>
              </a:r>
              <a:r>
                <a:rPr lang="en-US" sz="1100" b="1" dirty="0">
                  <a:solidFill>
                    <a:srgbClr val="00C5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b="1" dirty="0">
                  <a:solidFill>
                    <a:srgbClr val="23E1E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ck</a:t>
              </a:r>
            </a:p>
          </p:txBody>
        </p:sp>
        <p:pic>
          <p:nvPicPr>
            <p:cNvPr id="80" name="Graphic 79" descr="Arrow Right with solid fill">
              <a:extLst>
                <a:ext uri="{FF2B5EF4-FFF2-40B4-BE49-F238E27FC236}">
                  <a16:creationId xmlns:a16="http://schemas.microsoft.com/office/drawing/2014/main" id="{2C6B2CC3-9405-A302-977C-545F16D638A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96DAC541-7B7A-43D3-8B79-37D633B846F1}">
                  <asvg:svgBlip xmlns:asvg="http://schemas.microsoft.com/office/drawing/2016/SVG/main" r:embed="rId10"/>
                </a:ext>
              </a:extLst>
            </a:blip>
            <a:stretch>
              <a:fillRect/>
            </a:stretch>
          </p:blipFill>
          <p:spPr>
            <a:xfrm>
              <a:off x="2709817" y="3256824"/>
              <a:ext cx="452387" cy="4258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900469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700" row="0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19D8072B-D17B-4237-B950-68F6FE53205A}">
  <we:reference id="wa200006038" version="1.0.0.3" store="en-US" storeType="OMEX"/>
  <we:alternateReferences>
    <we:reference id="wa200006038" version="1.0.0.3" store="" storeType="OMEX"/>
  </we:alternateReferences>
  <we:properties/>
  <we:bindings/>
  <we:snapshot xmlns:r="http://schemas.openxmlformats.org/officeDocument/2006/relationships"/>
</we:webextension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d8b9b82-87f8-4d38-a474-60ce13ed8db9">
      <Terms xmlns="http://schemas.microsoft.com/office/infopath/2007/PartnerControls"/>
    </lcf76f155ced4ddcb4097134ff3c332f>
    <TaxCatchAll xmlns="7cbebcc7-c4f1-4358-9fbf-2885dbb4de4a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FE575491624AB478B4D7E4E41CDEDFF" ma:contentTypeVersion="18" ma:contentTypeDescription="Create a new document." ma:contentTypeScope="" ma:versionID="8ef4ff8999dc2e52535599d1c047f972">
  <xsd:schema xmlns:xsd="http://www.w3.org/2001/XMLSchema" xmlns:xs="http://www.w3.org/2001/XMLSchema" xmlns:p="http://schemas.microsoft.com/office/2006/metadata/properties" xmlns:ns2="8d8b9b82-87f8-4d38-a474-60ce13ed8db9" xmlns:ns3="7cbebcc7-c4f1-4358-9fbf-2885dbb4de4a" targetNamespace="http://schemas.microsoft.com/office/2006/metadata/properties" ma:root="true" ma:fieldsID="1ee2ccf9ffefdcc6cbfb6b2aa66d2423" ns2:_="" ns3:_="">
    <xsd:import namespace="8d8b9b82-87f8-4d38-a474-60ce13ed8db9"/>
    <xsd:import namespace="7cbebcc7-c4f1-4358-9fbf-2885dbb4de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LengthInSecond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d8b9b82-87f8-4d38-a474-60ce13ed8db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LengthInSeconds" ma:index="13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c66bcfc7-c51b-4bc8-8383-b8f609394d6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cbebcc7-c4f1-4358-9fbf-2885dbb4de4a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bb1b61c4-1e43-4db5-acea-8bd320a75541}" ma:internalName="TaxCatchAll" ma:showField="CatchAllData" ma:web="7cbebcc7-c4f1-4358-9fbf-2885dbb4de4a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2E282F7-0FC2-4B84-B285-D57CD491FC70}">
  <ds:schemaRefs>
    <ds:schemaRef ds:uri="http://purl.org/dc/dcmitype/"/>
    <ds:schemaRef ds:uri="http://schemas.microsoft.com/office/infopath/2007/PartnerControls"/>
    <ds:schemaRef ds:uri="8d8b9b82-87f8-4d38-a474-60ce13ed8db9"/>
    <ds:schemaRef ds:uri="http://purl.org/dc/elements/1.1/"/>
    <ds:schemaRef ds:uri="http://schemas.microsoft.com/office/2006/metadata/properties"/>
    <ds:schemaRef ds:uri="7cbebcc7-c4f1-4358-9fbf-2885dbb4de4a"/>
    <ds:schemaRef ds:uri="http://schemas.microsoft.com/office/2006/documentManagement/types"/>
    <ds:schemaRef ds:uri="http://schemas.openxmlformats.org/package/2006/metadata/core-properties"/>
    <ds:schemaRef ds:uri="http://www.w3.org/XML/1998/namespac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BFC41ED1-EC55-414D-83E1-22E56BA41DB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C002F57-176E-49CB-93CB-89F8E0C2FA38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d8b9b82-87f8-4d38-a474-60ce13ed8db9"/>
    <ds:schemaRef ds:uri="7cbebcc7-c4f1-4358-9fbf-2885dbb4de4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7481</TotalTime>
  <Words>66</Words>
  <Application>Microsoft Office PowerPoint</Application>
  <PresentationFormat>Custom</PresentationFormat>
  <Paragraphs>4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s hartman</dc:creator>
  <cp:lastModifiedBy>Lawrence, C Martin</cp:lastModifiedBy>
  <cp:revision>187</cp:revision>
  <cp:lastPrinted>2024-08-30T15:19:24Z</cp:lastPrinted>
  <dcterms:created xsi:type="dcterms:W3CDTF">2019-04-04T22:12:04Z</dcterms:created>
  <dcterms:modified xsi:type="dcterms:W3CDTF">2025-07-09T14:27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FE575491624AB478B4D7E4E41CDEDFF</vt:lpwstr>
  </property>
  <property fmtid="{D5CDD505-2E9C-101B-9397-08002B2CF9AE}" pid="3" name="Order">
    <vt:r8>500</vt:r8>
  </property>
  <property fmtid="{D5CDD505-2E9C-101B-9397-08002B2CF9AE}" pid="4" name="MediaServiceImageTags">
    <vt:lpwstr/>
  </property>
</Properties>
</file>